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64" r:id="rId3"/>
    <p:sldId id="267" r:id="rId4"/>
    <p:sldId id="269" r:id="rId5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16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571080-7BC8-D7EE-9F89-4A227C68C9E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2F02ED-96F5-E047-AA34-AB0233A391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B0592-BAF3-90F2-CC64-5A7C2E5E4C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24E1B0-A382-88A0-49F4-6F4D3E388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22191A-DE2F-D24E-4BB1-A5BF1FC9F5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47405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06C24B-4D17-27E8-8005-CEB9D92AFC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0D0BD7-F0F8-7FF1-AA00-9B3E2FE713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6265AE-0309-B29C-E42A-5B198D784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1E952A-71F2-0F92-37FB-A8F3AA3AB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BFDA15-E3A5-B203-F00F-494D716221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00134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4AD3BD5-30A5-D2D3-05D7-4C4F74506D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0E860B-3C77-F0D2-8963-E7A73791D0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EDF232-D29A-BF65-433E-57D29AAA1C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A38F00-4101-EF98-AC68-E2F07FAF85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6ED64A-71CF-63C2-2CC6-E178CAF81E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7735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1C2F2-9E46-09AC-3588-C68245B23B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0F6B9F-638A-A652-2945-72CAA82FC1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3E69A-D4F1-798B-86DD-8436448946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B46B24-5690-EF1D-A4E6-04A4356B0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C4EE26-E784-D9D3-3C60-B7C34EF6B0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2080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95E9D5-9355-8D31-6F2F-39B62E4757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C5A0C0-B99F-5557-F6C0-715F32500B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D69557-F336-FBC7-CB8B-444F0B3557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4C18DE-E3C2-38D3-B80E-C2F9491BBB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930B43-BD9C-024B-D1A0-8A028528D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8937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76B26F-EEAB-3EE2-A446-8013C1F777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8341DC-70E8-E5FB-2F56-C28AD66317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972DFE-F765-496A-B8FB-901202D08D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787588-AFF6-4968-A518-290A6CA47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200A6B-FEC8-B3E6-D46E-88D6D4E9C9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CC58B19-2353-DDF8-3FC7-E54467A65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0587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CBF96-4233-4695-0FD9-5BADF69640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84C5C4-EF19-5E66-06CC-1BF3F088C1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996E13-C1F0-B431-D241-219D43BA1C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8E45C7A-2FEA-230F-1530-CECE4515DC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F4B9E4-CB6E-C71A-83DA-6FEA5F15B8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BBB7FF-161E-7C1F-FD67-31E17F0DE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E255AC-81EF-A798-3F0B-99E524543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A909FA-C65F-4365-B6B3-70B8220A9D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53454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0DC87-1D59-CB5B-B90E-28C5F7094C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65FA0C-87A5-3874-729A-4C6483186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1A57A25-EE38-F544-F88D-2A049FBA96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E74D988-852C-D230-1392-AA0516264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56598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4232F0D-9753-049A-BCA6-6828383FE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FCF186-1705-B227-BC80-B198CAEDE0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C927933-F38D-346F-A38D-DDD3F7F6E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31299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4ACBC7-922E-BE24-C65C-505892CB8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1745EC-1C9E-034E-95A9-9820CDB0F5D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2DF6D6E-5915-49CD-1D42-5EF07E1768F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F80C51-61E3-1E07-3D2A-A46011615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DF00724-5763-3434-4481-9A5117E760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91A0D6-E485-52F3-7AB6-5CB200078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5600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2F49D4-670A-9FBD-A31A-3118C2680A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EAEB830-F36B-D840-DE28-55CDB36D14B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28D34DF-ABE8-6EE3-83D4-C87CC2064B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5C2B5C-ED80-0FAD-FEAE-CAEA315970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D7A790-988A-8762-2B50-7FDCAAEE1D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B66D9E-DD33-FC14-8FB9-A3022C9383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1734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494ED11-1864-1E5D-3FF2-6184861A0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5B05BF-F2C9-78CE-1AF0-90BA23F27B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E0A5FA-870D-5F4E-5911-A41CC1D21A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9403A47-AD8E-4421-A3C1-8883C8BA8328}" type="datetimeFigureOut">
              <a:rPr lang="en-GB" smtClean="0"/>
              <a:t>27/04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036D08-1B27-5ADA-AE05-E59911B742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03248D-5878-E0C1-4ABE-88769864055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C69AB9-F911-4A88-904D-3D4E4CE0AD5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72896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02828E8B-687A-ED73-51BA-54894881C01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12" t="7867" r="24732" b="6845"/>
          <a:stretch>
            <a:fillRect/>
          </a:stretch>
        </p:blipFill>
        <p:spPr>
          <a:xfrm>
            <a:off x="256032" y="341376"/>
            <a:ext cx="6205728" cy="5849112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D879A8B-5BBF-F0C5-2E43-A9DBA067F0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99" t="1554" r="17700" b="45"/>
          <a:stretch>
            <a:fillRect/>
          </a:stretch>
        </p:blipFill>
        <p:spPr>
          <a:xfrm>
            <a:off x="6461760" y="1374648"/>
            <a:ext cx="5173924" cy="410870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6D99B22-66AE-57E4-B030-53EACE059542}"/>
              </a:ext>
            </a:extLst>
          </p:cNvPr>
          <p:cNvSpPr txBox="1"/>
          <p:nvPr/>
        </p:nvSpPr>
        <p:spPr>
          <a:xfrm>
            <a:off x="9220128" y="6331958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5BA61B9-2A50-482B-1D4E-CFD7EA047F43}"/>
              </a:ext>
            </a:extLst>
          </p:cNvPr>
          <p:cNvSpPr txBox="1"/>
          <p:nvPr/>
        </p:nvSpPr>
        <p:spPr>
          <a:xfrm>
            <a:off x="551936" y="482846"/>
            <a:ext cx="450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</a:t>
            </a:r>
            <a:r>
              <a:rPr lang="en-GB" b="1" dirty="0" err="1"/>
              <a:t>i</a:t>
            </a:r>
            <a:r>
              <a:rPr lang="en-GB" b="1" dirty="0"/>
              <a:t>).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128A89-C9CE-F04B-0F03-C8E692ECE25A}"/>
              </a:ext>
            </a:extLst>
          </p:cNvPr>
          <p:cNvSpPr txBox="1"/>
          <p:nvPr/>
        </p:nvSpPr>
        <p:spPr>
          <a:xfrm>
            <a:off x="6261705" y="526042"/>
            <a:ext cx="5132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/>
              <a:t>(ii).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9234757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4A517F4-7ED0-129F-5D1B-6C95624B44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16704" y="872817"/>
            <a:ext cx="10158592" cy="51123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EF7BF3F-1C5F-331D-7A17-FF568A766F59}"/>
              </a:ext>
            </a:extLst>
          </p:cNvPr>
          <p:cNvSpPr txBox="1"/>
          <p:nvPr/>
        </p:nvSpPr>
        <p:spPr>
          <a:xfrm>
            <a:off x="9240782" y="6317892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19625167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776F1E1-C948-5591-E21A-2D119C8D0D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4200" y="1077586"/>
            <a:ext cx="5076434" cy="406114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F9ACB79-ED64-0D0C-7C70-710C96816917}"/>
              </a:ext>
            </a:extLst>
          </p:cNvPr>
          <p:cNvSpPr txBox="1"/>
          <p:nvPr/>
        </p:nvSpPr>
        <p:spPr>
          <a:xfrm>
            <a:off x="2212040" y="5701140"/>
            <a:ext cx="20310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B1167 GRE vs µg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6721DB0-061B-9758-58B0-53F1C68689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15744" y="1077586"/>
            <a:ext cx="5173162" cy="413852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77D8FED-E416-FF0D-7746-B38D93C5720C}"/>
              </a:ext>
            </a:extLst>
          </p:cNvPr>
          <p:cNvSpPr txBox="1"/>
          <p:nvPr/>
        </p:nvSpPr>
        <p:spPr>
          <a:xfrm>
            <a:off x="7519455" y="5701140"/>
            <a:ext cx="28020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B1167-HSP10 GRE vs µ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1F664E4-4DB2-614A-43B7-2B97C0D5CA8E}"/>
              </a:ext>
            </a:extLst>
          </p:cNvPr>
          <p:cNvSpPr txBox="1"/>
          <p:nvPr/>
        </p:nvSpPr>
        <p:spPr>
          <a:xfrm>
            <a:off x="1152394" y="778180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16259E-CBA5-2E49-0DE3-7FCBB98D9605}"/>
              </a:ext>
            </a:extLst>
          </p:cNvPr>
          <p:cNvSpPr txBox="1"/>
          <p:nvPr/>
        </p:nvSpPr>
        <p:spPr>
          <a:xfrm>
            <a:off x="6442954" y="778180"/>
            <a:ext cx="4408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.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CAF6AD-BA13-CFDE-F999-3B7994285202}"/>
              </a:ext>
            </a:extLst>
          </p:cNvPr>
          <p:cNvSpPr txBox="1"/>
          <p:nvPr/>
        </p:nvSpPr>
        <p:spPr>
          <a:xfrm>
            <a:off x="9171097" y="6391312"/>
            <a:ext cx="280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S3</a:t>
            </a:r>
          </a:p>
        </p:txBody>
      </p:sp>
    </p:spTree>
    <p:extLst>
      <p:ext uri="{BB962C8B-B14F-4D97-AF65-F5344CB8AC3E}">
        <p14:creationId xmlns:p14="http://schemas.microsoft.com/office/powerpoint/2010/main" val="9701210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D5DD74B3-0833-2264-CCC4-2267FC5C9BC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6890" y="1660787"/>
            <a:ext cx="4718219" cy="377457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EBF6C37-9D0E-3800-908D-9C1120A8DDB0}"/>
              </a:ext>
            </a:extLst>
          </p:cNvPr>
          <p:cNvSpPr txBox="1"/>
          <p:nvPr/>
        </p:nvSpPr>
        <p:spPr>
          <a:xfrm>
            <a:off x="3895866" y="5771964"/>
            <a:ext cx="3688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B1167 vs AB1167-HSP10 in G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BEB10AB1-CA29-9930-5135-F798AA3B7185}"/>
              </a:ext>
            </a:extLst>
          </p:cNvPr>
          <p:cNvSpPr txBox="1"/>
          <p:nvPr/>
        </p:nvSpPr>
        <p:spPr>
          <a:xfrm>
            <a:off x="9181147" y="6464914"/>
            <a:ext cx="280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S4</a:t>
            </a:r>
          </a:p>
        </p:txBody>
      </p:sp>
    </p:spTree>
    <p:extLst>
      <p:ext uri="{BB962C8B-B14F-4D97-AF65-F5344CB8AC3E}">
        <p14:creationId xmlns:p14="http://schemas.microsoft.com/office/powerpoint/2010/main" val="2039801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</TotalTime>
  <Words>35</Words>
  <Application>Microsoft Office PowerPoint</Application>
  <PresentationFormat>Widescreen</PresentationFormat>
  <Paragraphs>1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he University of Liverpo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Jackson, Malcolm</dc:creator>
  <cp:lastModifiedBy>Jones, Samantha [swjones1]</cp:lastModifiedBy>
  <cp:revision>11</cp:revision>
  <cp:lastPrinted>2026-04-10T15:06:36Z</cp:lastPrinted>
  <dcterms:created xsi:type="dcterms:W3CDTF">2025-03-21T10:10:43Z</dcterms:created>
  <dcterms:modified xsi:type="dcterms:W3CDTF">2026-04-27T19:29:41Z</dcterms:modified>
</cp:coreProperties>
</file>